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20"/>
  </p:normalViewPr>
  <p:slideViewPr>
    <p:cSldViewPr snapToGrid="0" snapToObjects="1">
      <p:cViewPr varScale="1">
        <p:scale>
          <a:sx n="95" d="100"/>
          <a:sy n="95" d="100"/>
        </p:scale>
        <p:origin x="61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EF9030-B2FB-7445-A95F-6466D8217D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A89B5AF-4B3A-EA4D-A622-6E7F66FB5D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2D6265-88C2-A541-88B4-C05457261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78CF5-037D-314C-986D-41600A33D7DB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A690EB-B04C-054E-BF94-3EC81E4D0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8D2263-9004-4F41-A41F-79AD5D2F5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9DC57-0A47-DB41-9CB3-3E52BB9E4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0136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650269-8360-A246-B559-887369FF6D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38A1A1-F729-BB4E-BA3D-395B4703CC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447806-B4B4-8742-BABD-EE73977AD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78CF5-037D-314C-986D-41600A33D7DB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A0289F-5573-DD4C-97FA-450B643DD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FA60B9-CDB7-BA42-843C-C6774773D8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9DC57-0A47-DB41-9CB3-3E52BB9E4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9532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4DED404-4D20-AD46-8426-DA115769E0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58574C-84A0-3E49-A31A-38938B7C0B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7A4C6B-9D4E-0A48-8449-6825F661E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78CF5-037D-314C-986D-41600A33D7DB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AE672E-AB52-274A-B838-B288D47CE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B96A95-CC4A-994E-B39F-DE815FE9D4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9DC57-0A47-DB41-9CB3-3E52BB9E4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662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6382E4-55B2-C344-B4C3-C20DC31E4B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BF8EAF-B2E9-F249-B07C-3691483148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E8F9D7-869A-5A4F-BA7A-A5A751274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78CF5-037D-314C-986D-41600A33D7DB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5A6CB2-68BC-EF41-A3DC-C07B0750B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4194E2-D03D-114A-9294-810E41CE7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9DC57-0A47-DB41-9CB3-3E52BB9E4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77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8A2F23-3E6A-574B-901A-690ABAE757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B52796-5084-5F45-9BFF-94CB62A946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99F2F4-EC42-4340-AE09-0422042BA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78CF5-037D-314C-986D-41600A33D7DB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BCAFD3-D738-B24F-A86E-C19027E080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53A6C7-1783-7840-85DF-9670A34057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9DC57-0A47-DB41-9CB3-3E52BB9E4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077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FE541A-B736-1A44-A0C2-F2307E934C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D58FBC-1F07-5540-8259-93E16CF11B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E42C2B-DDCA-1647-AE3A-F3EBC20E86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579C50-9F0C-264A-9066-9C66F981C6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78CF5-037D-314C-986D-41600A33D7DB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FCD018-2C01-1D46-BACE-FEEA9BC28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376078-5CD4-6A48-9ACD-3CCD6E164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9DC57-0A47-DB41-9CB3-3E52BB9E4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906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B1D28-E4DC-FB4D-B66C-856143509E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36538F-4ECC-6941-805F-7A6C0C4D4C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4297D2-EA32-2C49-8083-E1A649236E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1D8614A-DA38-1142-97C8-6A5A310D45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4391E1A-BFFE-DC49-BEF8-CBEC9068E5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6CADA18-1E55-7141-BE5B-49773377C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78CF5-037D-314C-986D-41600A33D7DB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6F096CB-CCD7-D244-BD74-7BC64C2ED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531D64-DAE9-A348-84B3-989E77F9B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9DC57-0A47-DB41-9CB3-3E52BB9E4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223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91BA96-CE2C-F34A-AFC1-3F330E86B1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82900F0-2FC6-C04D-9504-61F939DE1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78CF5-037D-314C-986D-41600A33D7DB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53169DD-16C1-C94C-AE13-CD2F3A24A6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0A61B1-7EFA-B74B-91E7-637DF4A305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9DC57-0A47-DB41-9CB3-3E52BB9E4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651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DF7F7EC-8549-1742-93DF-11B22B12F0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78CF5-037D-314C-986D-41600A33D7DB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F1C6FBB-4C81-DB48-9FEF-E74B77FAB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14C0FC-E52D-4043-AD55-31F01C01A2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9DC57-0A47-DB41-9CB3-3E52BB9E4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9643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092B55-2A0F-C74F-82DC-7DE7E2667F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8DE61B-4DBE-4C43-8070-3FB0AEAFC6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94101A-EE1B-0F42-8607-2B7E416D9A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0F6809-1461-5D4B-B549-7331FEC95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78CF5-037D-314C-986D-41600A33D7DB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6D31AE-A336-B24A-9A39-C8BD939AC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5D0DE8-40DA-2446-B049-1FA4548B4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9DC57-0A47-DB41-9CB3-3E52BB9E4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311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98BD32-1ABC-1E4A-9DCB-AB5D61D119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84CAB47-374B-0247-827F-7F7942E3D8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5023F6-8105-1C47-8985-5DA837F2CE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A62D95-F740-9A4B-BDE6-4A41C29ABD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78CF5-037D-314C-986D-41600A33D7DB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85E93D-ED93-3F41-8ACC-03A2D61C5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81B420-6307-A740-8773-FA235000C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9DC57-0A47-DB41-9CB3-3E52BB9E4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45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6FCDC7-F8C3-D94F-80AE-64CF1ECB9B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44F973-2CEF-0F45-87D7-68712C289D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9B2E73-4133-F84B-AF0C-04EE9D1081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78CF5-037D-314C-986D-41600A33D7DB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3649B1-E125-9741-94E3-4A5D022900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CF35F6-0609-5D4C-A35B-FC52DAD8B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89DC57-0A47-DB41-9CB3-3E52BB9E4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346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50">
            <a:extLst>
              <a:ext uri="{FF2B5EF4-FFF2-40B4-BE49-F238E27FC236}">
                <a16:creationId xmlns:a16="http://schemas.microsoft.com/office/drawing/2014/main" id="{CF4ECE92-F8B4-6D46-8010-D08552699CCE}"/>
              </a:ext>
            </a:extLst>
          </p:cNvPr>
          <p:cNvSpPr txBox="1"/>
          <p:nvPr/>
        </p:nvSpPr>
        <p:spPr>
          <a:xfrm>
            <a:off x="461439" y="5632942"/>
            <a:ext cx="1126912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: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Venn diagrams corresponding to Figure 1, showing the list of genes used for immune cell type profiling A) and cell function profiling B) (as defined by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NanoString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Figueiredo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et al. [26] and </a:t>
            </a:r>
            <a:r>
              <a:rPr lang="en-GB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Waks</a:t>
            </a:r>
            <a:r>
              <a:rPr lang="en-GB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et al [31]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ED6638CE-D1F7-B641-997D-C979DB3FBE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7699" y="1355686"/>
            <a:ext cx="5473256" cy="3281934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461439" y="792154"/>
            <a:ext cx="156805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) Cell-type profiling</a:t>
            </a:r>
            <a:endParaRPr lang="en-GB" sz="11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9F1DEB2-35F0-AA49-9978-94311B0A16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99201" y="1355685"/>
            <a:ext cx="5431366" cy="3641253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417295" y="792154"/>
            <a:ext cx="13035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) Cell functions</a:t>
            </a:r>
            <a:endParaRPr lang="en-GB" sz="1100" b="1" dirty="0"/>
          </a:p>
        </p:txBody>
      </p:sp>
    </p:spTree>
    <p:extLst>
      <p:ext uri="{BB962C8B-B14F-4D97-AF65-F5344CB8AC3E}">
        <p14:creationId xmlns:p14="http://schemas.microsoft.com/office/powerpoint/2010/main" val="24167571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</TotalTime>
  <Words>58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bat-Pospiech, Dorota</dc:creator>
  <cp:lastModifiedBy>MDPI japan</cp:lastModifiedBy>
  <cp:revision>16</cp:revision>
  <dcterms:created xsi:type="dcterms:W3CDTF">2020-06-16T10:09:09Z</dcterms:created>
  <dcterms:modified xsi:type="dcterms:W3CDTF">2020-09-30T05:34:44Z</dcterms:modified>
</cp:coreProperties>
</file>